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410" r:id="rId2"/>
    <p:sldId id="411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72"/>
  </p:normalViewPr>
  <p:slideViewPr>
    <p:cSldViewPr snapToGrid="0">
      <p:cViewPr varScale="1">
        <p:scale>
          <a:sx n="111" d="100"/>
          <a:sy n="111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50F251-F78D-5726-BA52-021747D419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6CABF00-DF17-56F2-F602-65AB24806C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F33DD13-2EE1-C134-CC43-A2B3A7992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6F8021F-77BD-CDC0-147C-29ED15D30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B8E985-7414-8B41-3F1E-82E1DFF8D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13190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AB784C-76B3-2BF9-6DDD-298B81F9C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7F5F460-0D33-8DB3-CD2F-5E0B2020C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FDE4715-11A7-18D9-EB01-5FFF5BA1D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B1C48DA-804F-94EE-18ED-4321ED6C8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E544B58-42E5-A15C-0DEB-BD26FF8C5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8865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7142206-8EED-6EC4-80DC-6D429B421E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879DEC2-6660-4C73-F323-BE101B052A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C7742A8-7748-D469-9831-95B74A2C4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B5C93E1-0558-4AF5-6D15-2401C5B93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52D258A-E887-4428-F17F-675E1ADA7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15974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DA2812-E6D6-5765-A142-CCA8CE5549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BDFE138-6317-4835-6770-E877AD801F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31A9125-F5CB-5CCF-F11E-646882A78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31785B9-6DB5-C921-FE30-BDD957876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7D8063A-5D69-7C68-637B-82D93144C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73831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5513A1D-A1D7-71E9-98D4-1F7BE5952A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8DB19A9-C259-F170-AF75-472D5AA59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82AFBA-84F9-C1E0-FECA-331DFDFFD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89CC2CB-9AB1-E533-FC08-1546118E6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F58097D-ED8B-6565-4EC3-6393103AC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88845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9F5C5B-232E-996E-D52A-A12814ECE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C6E1AE8-A077-6589-08CB-F19DF02728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999FE3E-119F-4172-22CE-CCCDFD85B7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02F49FA-1086-F0C8-A69A-8D07C8CA6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C6A04C3-C2C8-0C50-2A8D-D4A1AEFEF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884A8B0-D094-8DE9-31F5-BB13F236D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50060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478F47-7F7B-5F01-FBEC-591FB998FE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CA14DF7-A0BB-E4B3-D2E1-CC8FDB6016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544863D-B322-99E9-2ADE-FE9CC887B0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016DC41-A656-F112-9922-46F9AABEE5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ADE1754-448A-5982-2784-F907E01AE6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7653158-2FFB-D5D7-D250-187BAA8B6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B648BEC-D123-65A2-8048-6E1B44EF1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6DF165D-B8A8-19AC-2481-B9336E3F5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58618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4F8082E-E2B6-6590-A9A6-D5078356A4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480487D-E90C-0864-467D-4FAD5CD88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0FE4C02-736F-7D0C-A9D7-73D168F82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58C143D-83BE-EE59-C77F-78F969A92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0555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4DD1F87-1E28-65C5-11C8-48D664562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C6CC90E-199A-0CB2-7D95-42724DC33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B3FFB42-559A-569B-F2DB-3C0D8A9A3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8742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90D37AD-3640-BD04-784A-09E4094A8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B6B0C04-557D-F813-96C5-9E935CA6FD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1168E7A-294B-4C04-EA87-956ACFD32E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E9A05EE-04F8-C2D6-B47A-8DE516408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8A333A1-8C6B-EF57-2E70-34E16F654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6DD5B0C-FE51-FD41-F584-03DF9E473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38936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0056C5-50AA-8287-CFF9-21A6B66A6D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1ED8C34-2647-CD4D-12A5-E79CFF7AF4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570155D-B48B-A466-82D4-B8D6612A70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F82B44A-A3EE-4A2A-AB80-4F8C7E0FD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FB7F3C5-470F-C123-5B40-6D63A1C46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576549C-28EA-85AD-A344-02D63EB50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30537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6AF68DA-4A7C-8834-DABE-FB9224569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B9FD399-0550-F19E-0B06-A614C6E74B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50D7A31-B148-F176-E783-1C1E1EC28D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63AE4-E4C2-194A-B88B-C26F1DA1AC1B}" type="datetimeFigureOut">
              <a:rPr lang="es-MX" smtClean="0"/>
              <a:t>11/11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12E193E-1A4B-4928-FA09-DF350F817D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783319B-1BCE-3F97-7495-85A3B17189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A8EBCC-261D-504C-A4C3-7A2D6BA8BD6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33647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1062470-2836-4F64-B50C-E5A0A17987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06" y="42545"/>
            <a:ext cx="1215083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9155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90BE9F-8013-4C6F-8937-AF4A224145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60558"/>
            <a:ext cx="10515600" cy="5536883"/>
          </a:xfrm>
        </p:spPr>
        <p:txBody>
          <a:bodyPr>
            <a:noAutofit/>
          </a:bodyPr>
          <a:lstStyle/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e expression profiles based on microarrays was carried out in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east Cancer (BC)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mor samples from Biopsy (BS) at diagnostic time and from Surgery (SS) after neoadjuvant chemotherapy treatment (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CT) with cyclophosphamide-doxorubicin/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pirubicin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 define tumor molecular adaptations to a chemotherapy in patients who showed pathologic complete response (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R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therapeutic failure (non-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R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fter NCT</a:t>
            </a: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signature of 43 differentially expressed genes discriminated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R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non-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R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tients [|fold change &gt; 2|, false discovery rate &lt; 0.05] only in biopsies taken from surgery. Based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 unsupervised clustering of gene expression, together with functional enrichment analyses of differentially expressed genes, we selected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SAP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LAF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 also analyze the correlation between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SAP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LAF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gainst disease-free survival (DFS) and overall survival (OS).</a:t>
            </a: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ients achieving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R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owed downregulation of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SAP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LAF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tumor tissues and increased DFS and OS, while overexpression of these genes correlated with poor therapeutic response and OS. These genes are involved in the regulation of mitotic division.</a:t>
            </a:r>
          </a:p>
          <a:p>
            <a:pPr marL="0" marR="0" indent="0">
              <a:lnSpc>
                <a:spcPct val="200000"/>
              </a:lnSpc>
              <a:spcBef>
                <a:spcPts val="680"/>
              </a:spcBef>
              <a:spcAft>
                <a:spcPts val="0"/>
              </a:spcAft>
              <a:buNone/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clusions: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downregulation of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SAP1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LAF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fter NCT is associated with the tumor response to chemotherapy and patient survival.</a:t>
            </a:r>
          </a:p>
          <a:p>
            <a:pPr marL="0" indent="0">
              <a:buNone/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/>
            </a:r>
            <a:b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64896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208</Words>
  <Application>Microsoft Office PowerPoint</Application>
  <PresentationFormat>Panorámica</PresentationFormat>
  <Paragraphs>5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USAP1 and PCLAF: predictors in pR and survival</dc:title>
  <dc:creator>Gerardo Israel Magallanes Garza</dc:creator>
  <cp:lastModifiedBy>Nayelly Nohemi Hernandez Galvan</cp:lastModifiedBy>
  <cp:revision>5</cp:revision>
  <dcterms:created xsi:type="dcterms:W3CDTF">2022-09-30T16:45:13Z</dcterms:created>
  <dcterms:modified xsi:type="dcterms:W3CDTF">2022-11-11T15:15:55Z</dcterms:modified>
</cp:coreProperties>
</file>